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3" d="100"/>
          <a:sy n="63" d="100"/>
        </p:scale>
        <p:origin x="6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769004-9AB6-4A2E-A2D5-8F3938E9F3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E5047ED-104E-4C5A-A47F-548CAE5436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006D09A-BB29-4246-BFF1-8211C2CDE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1DE732F-D904-47E0-9D61-A27B36207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3B2B8B0-E6C2-4ACA-8425-59BE3CBE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7737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FBF74F-7ECF-4935-B41F-EAC94C9902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8FC8410-FF19-458F-B764-ADB04BCEF2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2E63B1-2818-4580-9F76-3BA32821B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8C3B626-CAE2-4DA8-8D20-693D343A5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EE8427-D4AD-4860-AAC2-466C3EAD0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1993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77DF97B-9DF1-41D1-B848-B0E2D6018C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BADBDE4-74C4-4E1B-A159-D4C60FB4F1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475C4F-65C0-4151-8D50-DB5BFF26A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46D7F6F-6C44-42BD-A146-2C8B29B42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E567EFF-FD7D-4B5C-B0A2-ED65AFB1E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7748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39CEF7-07C2-4C87-8FEE-953519D25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42A529A-7407-4E60-81D1-BC653F83FA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DA12C62-A0CF-4A31-A3B1-21ACBEB50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96F352D-2B78-49AD-B5D8-296AFEC4B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7B6C8A-6AB5-45FB-B634-17070FD2E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050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D13D9A-CDC6-4793-BA83-EEA847DD7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96D3A28-1637-4573-8717-12D5FE77F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D03DFF-2279-4BC0-AE27-B13700D2A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8252E74-1D5A-43F7-A44A-C45C0AB52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D24B6B5-39F7-4E0F-89FD-489EFB73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06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DF0EEF-C42D-43F4-937D-953E956B5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0401D83-372F-4EEA-8FB4-9C34A81D26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05FCD2E-DBBF-4511-A4A2-38278987EB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D274AAB-736E-42F7-A2A9-AE222A54F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7508AE8-FDA4-4EC5-B67A-BAA5769B2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C899BC6-2284-4DCA-8C1D-DD414B662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1539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39F1FA-EE64-43DA-A39B-5F4C42C63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EB6AF6A-760A-495D-85A8-367713E5CD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A79BFA3-9824-4524-8B08-D225962914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22FC7F2-5149-40E2-AEA7-11005B56B3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0257000-C68A-4721-BC68-DA373C05F7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EBA11E9-5902-4C91-8E27-3F957D295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184C747-F9EA-41F8-BDA7-D4AF0563D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8158A09-3CCC-47A2-A284-98E34AF87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0818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0A3807-90B2-4A58-91BA-303EA61F9B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A62BD3D-C6FC-4726-A70C-FB3BC45DB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A2A18FD-FD2E-440D-B57A-73E3569BF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497F9AB-2DE5-476B-8021-6F8DE51CF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534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A77B22D-120B-4ED3-A0D4-77F0CA98A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A34541D-F267-44C7-BFA1-3C718DFA8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6F4FD71-60F1-4C40-9B43-D24382DE5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8382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83DE37-7E8D-47D0-B83C-C7F9913DA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EBF337F-9FEE-4E79-AC20-A2A9516C8D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1E79946-94B8-499A-A161-257552A131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59B7D36-C265-4702-9BA8-8D4B5E528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304AC3E-E0F7-4CE6-B706-750BC816E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37D057-054C-46BC-94DF-8F33E3AE5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3040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007E6F-D6A5-4A62-B538-9268B2DEF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2D9A258-86BE-4F40-A58F-D2F6438571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B18CD50-91B8-4EEC-A09A-ADD7545B9F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EC3D531-6097-4E1D-BBF1-9B51B9A4E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A0C1296-E2B8-48D3-A743-119A65A43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7DBEA0-9364-4C71-BBE4-5A6462EA5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4242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430C0D4-B20B-4FD1-8E62-CAED55A46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93E712D-AEA9-4240-98C4-8AB06C78BD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A82547-F110-401C-B41A-385CE993CA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0F4A6-F556-440C-BB1F-DBE7048DDDE1}" type="datetimeFigureOut">
              <a:rPr lang="it-IT" smtClean="0"/>
              <a:t>15/1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ADF8BD-F678-47DE-86F6-A846D1BEA4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52E880-F87D-49B2-BE95-EC33BE285C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7C948-051C-440D-95B0-D76818D146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1846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F79DACFB-7817-4930-8769-5BFE3837FB3A}"/>
              </a:ext>
            </a:extLst>
          </p:cNvPr>
          <p:cNvSpPr txBox="1"/>
          <p:nvPr/>
        </p:nvSpPr>
        <p:spPr>
          <a:xfrm>
            <a:off x="933061" y="858416"/>
            <a:ext cx="1013304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Protein network analyses of Pulmonary Endothelial Cells in Chronic Thromboembolic Pulmonary Hypertension </a:t>
            </a:r>
            <a:endParaRPr lang="it-IT" dirty="0"/>
          </a:p>
          <a:p>
            <a:r>
              <a:rPr lang="en-GB" b="1" dirty="0"/>
              <a:t> </a:t>
            </a:r>
            <a:endParaRPr lang="it-IT" dirty="0"/>
          </a:p>
          <a:p>
            <a:r>
              <a:rPr lang="it-IT" dirty="0" err="1"/>
              <a:t>Sarath</a:t>
            </a:r>
            <a:r>
              <a:rPr lang="it-IT" dirty="0"/>
              <a:t> </a:t>
            </a:r>
            <a:r>
              <a:rPr lang="it-IT" dirty="0" err="1"/>
              <a:t>Babu</a:t>
            </a:r>
            <a:r>
              <a:rPr lang="it-IT" dirty="0"/>
              <a:t> Nukala</a:t>
            </a:r>
            <a:r>
              <a:rPr lang="it-IT" baseline="30000" dirty="0"/>
              <a:t>1, 8 $</a:t>
            </a:r>
            <a:r>
              <a:rPr lang="it-IT" dirty="0"/>
              <a:t>*, Olga Tura-Ceide</a:t>
            </a:r>
            <a:r>
              <a:rPr lang="it-IT" baseline="30000" dirty="0"/>
              <a:t>3,4,5 $</a:t>
            </a:r>
            <a:r>
              <a:rPr lang="it-IT" dirty="0"/>
              <a:t>, Giancarlo Aldini</a:t>
            </a:r>
            <a:r>
              <a:rPr lang="it-IT" baseline="30000" dirty="0"/>
              <a:t>1</a:t>
            </a:r>
            <a:r>
              <a:rPr lang="it-IT" dirty="0"/>
              <a:t>, </a:t>
            </a:r>
            <a:r>
              <a:rPr lang="it-IT" dirty="0" err="1"/>
              <a:t>Valérie</a:t>
            </a:r>
            <a:r>
              <a:rPr lang="it-IT" dirty="0"/>
              <a:t> Smolders</a:t>
            </a:r>
            <a:r>
              <a:rPr lang="it-IT" baseline="30000" dirty="0"/>
              <a:t>2,4</a:t>
            </a:r>
            <a:r>
              <a:rPr lang="it-IT" dirty="0"/>
              <a:t>, Isabel Blanco</a:t>
            </a:r>
            <a:r>
              <a:rPr lang="it-IT" baseline="30000" dirty="0"/>
              <a:t>3,4</a:t>
            </a:r>
            <a:r>
              <a:rPr lang="it-IT" dirty="0"/>
              <a:t>, Victor I. Peinado</a:t>
            </a:r>
            <a:r>
              <a:rPr lang="it-IT" baseline="30000" dirty="0"/>
              <a:t>3,4</a:t>
            </a:r>
            <a:r>
              <a:rPr lang="it-IT" dirty="0"/>
              <a:t>, Manuel Castellà</a:t>
            </a:r>
            <a:r>
              <a:rPr lang="it-IT" baseline="30000" dirty="0"/>
              <a:t>6</a:t>
            </a:r>
            <a:r>
              <a:rPr lang="it-IT" dirty="0"/>
              <a:t>, Joan Albert Barberà</a:t>
            </a:r>
            <a:r>
              <a:rPr lang="it-IT" baseline="30000" dirty="0"/>
              <a:t>3,4,</a:t>
            </a:r>
            <a:r>
              <a:rPr lang="it-IT" dirty="0"/>
              <a:t>, Alessandra Altomare</a:t>
            </a:r>
            <a:r>
              <a:rPr lang="it-IT" baseline="30000" dirty="0"/>
              <a:t>1</a:t>
            </a:r>
            <a:r>
              <a:rPr lang="it-IT" dirty="0"/>
              <a:t>, Giovanna Baron</a:t>
            </a:r>
            <a:r>
              <a:rPr lang="it-IT" baseline="30000" dirty="0"/>
              <a:t>1</a:t>
            </a:r>
            <a:r>
              <a:rPr lang="it-IT" dirty="0"/>
              <a:t>, Marina Carini</a:t>
            </a:r>
            <a:r>
              <a:rPr lang="it-IT" baseline="30000" dirty="0"/>
              <a:t>1</a:t>
            </a:r>
            <a:r>
              <a:rPr lang="it-IT" dirty="0"/>
              <a:t>, Marta Cascante</a:t>
            </a:r>
            <a:r>
              <a:rPr lang="it-IT" baseline="30000" dirty="0"/>
              <a:t>2,7+ </a:t>
            </a:r>
            <a:r>
              <a:rPr lang="it-IT" dirty="0"/>
              <a:t>and Alfonsina D’Amato</a:t>
            </a:r>
            <a:r>
              <a:rPr lang="it-IT" baseline="30000" dirty="0"/>
              <a:t>1+</a:t>
            </a:r>
            <a:r>
              <a:rPr lang="it-IT" dirty="0"/>
              <a:t>*</a:t>
            </a:r>
          </a:p>
          <a:p>
            <a:r>
              <a:rPr lang="it-IT" dirty="0"/>
              <a:t> 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49910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screenshot&#10;&#10;Descrizione generata automaticamente">
            <a:extLst>
              <a:ext uri="{FF2B5EF4-FFF2-40B4-BE49-F238E27FC236}">
                <a16:creationId xmlns:a16="http://schemas.microsoft.com/office/drawing/2014/main" id="{338CFD15-9A8F-4FAE-9567-DFDE901879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384" y="1405128"/>
            <a:ext cx="6047232" cy="404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215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mappa, testo&#10;&#10;Descrizione generata automaticamente">
            <a:extLst>
              <a:ext uri="{FF2B5EF4-FFF2-40B4-BE49-F238E27FC236}">
                <a16:creationId xmlns:a16="http://schemas.microsoft.com/office/drawing/2014/main" id="{FCD7483F-A859-419C-9C29-AAA93245D4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52"/>
          <a:stretch/>
        </p:blipFill>
        <p:spPr>
          <a:xfrm>
            <a:off x="556660" y="0"/>
            <a:ext cx="6805259" cy="659384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2793E2F2-CCC0-4E1C-881E-4A2875B7ED46}"/>
              </a:ext>
            </a:extLst>
          </p:cNvPr>
          <p:cNvSpPr txBox="1"/>
          <p:nvPr/>
        </p:nvSpPr>
        <p:spPr>
          <a:xfrm>
            <a:off x="7231224" y="2845838"/>
            <a:ext cx="496077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. Figure 2: Pathways involved in Metabolism of reactive oxygen species significantly altered in CTEPH patients (last version IPA, QIAGEN </a:t>
            </a:r>
            <a:r>
              <a:rPr lang="en-GB" dirty="0" err="1"/>
              <a:t>Inc.,https</a:t>
            </a:r>
            <a:r>
              <a:rPr lang="en-GB" dirty="0"/>
              <a:t>://www.qiagenbioinformatics.com/products/ingenuitypathway-analysis), </a:t>
            </a:r>
            <a:r>
              <a:rPr lang="en-GB" dirty="0" err="1"/>
              <a:t>i</a:t>
            </a:r>
            <a:r>
              <a:rPr lang="en-US" dirty="0"/>
              <a:t>n red the increased genes, in green those decreased.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10965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accessorio, ombrello, mappa&#10;&#10;Descrizione generata automaticamente">
            <a:extLst>
              <a:ext uri="{FF2B5EF4-FFF2-40B4-BE49-F238E27FC236}">
                <a16:creationId xmlns:a16="http://schemas.microsoft.com/office/drawing/2014/main" id="{959DA9E9-0C68-4658-8F3D-6D2834C15A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52"/>
          <a:stretch/>
        </p:blipFill>
        <p:spPr>
          <a:xfrm>
            <a:off x="555547" y="0"/>
            <a:ext cx="6788824" cy="6593840"/>
          </a:xfrm>
          <a:prstGeom prst="rect">
            <a:avLst/>
          </a:prstGeom>
        </p:spPr>
      </p:pic>
      <p:sp>
        <p:nvSpPr>
          <p:cNvPr id="4" name="Rettangolo 3">
            <a:extLst>
              <a:ext uri="{FF2B5EF4-FFF2-40B4-BE49-F238E27FC236}">
                <a16:creationId xmlns:a16="http://schemas.microsoft.com/office/drawing/2014/main" id="{A2594DF4-37B6-4780-A8B0-6B0E3C84FE03}"/>
              </a:ext>
            </a:extLst>
          </p:cNvPr>
          <p:cNvSpPr/>
          <p:nvPr/>
        </p:nvSpPr>
        <p:spPr>
          <a:xfrm>
            <a:off x="7344371" y="2498059"/>
            <a:ext cx="462680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uppl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Figure 3: Pathways involved in fatty acid Metabolism altered in CTEPH patients (last version IPA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QIAGENIn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,https://www.qiagenbioinformatics.com/products/ingenuitypathway-analysis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n red the increased genes, in green those decreased. 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3612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accessorio, ombrello&#10;&#10;Descrizione generata automaticamente">
            <a:extLst>
              <a:ext uri="{FF2B5EF4-FFF2-40B4-BE49-F238E27FC236}">
                <a16:creationId xmlns:a16="http://schemas.microsoft.com/office/drawing/2014/main" id="{2BD7320E-B418-4ADF-996B-0AE31603C8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148"/>
          <a:stretch/>
        </p:blipFill>
        <p:spPr>
          <a:xfrm>
            <a:off x="696686" y="0"/>
            <a:ext cx="6830216" cy="6573520"/>
          </a:xfrm>
          <a:prstGeom prst="rect">
            <a:avLst/>
          </a:prstGeom>
        </p:spPr>
      </p:pic>
      <p:sp>
        <p:nvSpPr>
          <p:cNvPr id="4" name="Rettangolo 3">
            <a:extLst>
              <a:ext uri="{FF2B5EF4-FFF2-40B4-BE49-F238E27FC236}">
                <a16:creationId xmlns:a16="http://schemas.microsoft.com/office/drawing/2014/main" id="{D10B1B83-BDAA-40D7-9FD7-32EEA61971EC}"/>
              </a:ext>
            </a:extLst>
          </p:cNvPr>
          <p:cNvSpPr/>
          <p:nvPr/>
        </p:nvSpPr>
        <p:spPr>
          <a:xfrm>
            <a:off x="7344371" y="2498059"/>
            <a:ext cx="476676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uppl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Figure 4: Pathways involved in concentration of lipid altered in CTEPH patients (last version IPA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QIAGENIn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,https://www.qiagenbioinformatics.com/products/ingenuitypathway-analysis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n red the increased genes, in green those decreased. 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8451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pie chart, radar chart&#10;&#10;Description automatically generated">
            <a:extLst>
              <a:ext uri="{FF2B5EF4-FFF2-40B4-BE49-F238E27FC236}">
                <a16:creationId xmlns:a16="http://schemas.microsoft.com/office/drawing/2014/main" id="{17A5DB94-6D67-44E9-B4C8-B1651CBC4B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12"/>
          <a:stretch/>
        </p:blipFill>
        <p:spPr>
          <a:xfrm>
            <a:off x="557377" y="0"/>
            <a:ext cx="6850685" cy="6644640"/>
          </a:xfrm>
          <a:prstGeom prst="rect">
            <a:avLst/>
          </a:prstGeom>
        </p:spPr>
      </p:pic>
      <p:sp>
        <p:nvSpPr>
          <p:cNvPr id="4" name="Rettangolo 3">
            <a:extLst>
              <a:ext uri="{FF2B5EF4-FFF2-40B4-BE49-F238E27FC236}">
                <a16:creationId xmlns:a16="http://schemas.microsoft.com/office/drawing/2014/main" id="{06979347-BD1A-4EDE-B8D6-6256BCDE4B14}"/>
              </a:ext>
            </a:extLst>
          </p:cNvPr>
          <p:cNvSpPr/>
          <p:nvPr/>
        </p:nvSpPr>
        <p:spPr>
          <a:xfrm>
            <a:off x="7408062" y="1009501"/>
            <a:ext cx="336879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uppl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Figure 5: Pathways involved in inflammation altered in CTEPH patients (last version IPA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QIAGENIn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, https://www.qiagenbioinformatics.com/products/ingenuitypathway-analysis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n red the increased genes, in green those decreased. 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49650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43</Words>
  <Application>Microsoft Office PowerPoint</Application>
  <PresentationFormat>Widescreen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ascolese</dc:creator>
  <cp:lastModifiedBy>Alfonsina D'amato</cp:lastModifiedBy>
  <cp:revision>9</cp:revision>
  <dcterms:created xsi:type="dcterms:W3CDTF">2020-07-02T07:28:55Z</dcterms:created>
  <dcterms:modified xsi:type="dcterms:W3CDTF">2020-12-15T07:35:02Z</dcterms:modified>
</cp:coreProperties>
</file>